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60" r:id="rId3"/>
    <p:sldId id="261" r:id="rId4"/>
    <p:sldId id="262" r:id="rId5"/>
    <p:sldId id="263" r:id="rId6"/>
    <p:sldId id="264" r:id="rId7"/>
    <p:sldId id="266" r:id="rId8"/>
    <p:sldId id="267" r:id="rId9"/>
    <p:sldId id="268" r:id="rId10"/>
    <p:sldId id="265" r:id="rId11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743"/>
    <p:restoredTop sz="96327"/>
  </p:normalViewPr>
  <p:slideViewPr>
    <p:cSldViewPr snapToGrid="0" snapToObjects="1">
      <p:cViewPr varScale="1">
        <p:scale>
          <a:sx n="128" d="100"/>
          <a:sy n="128" d="100"/>
        </p:scale>
        <p:origin x="34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395B0F-BA64-B146-B757-98486D2E6D1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E517A7E-29D9-0D49-8733-B971AD2F206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0D7AF0A-AA41-B640-97B2-86881A392C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79C092-4A4A-EA4A-975E-A9AB075828AA}" type="datetimeFigureOut">
              <a:rPr lang="en-US" smtClean="0"/>
              <a:t>3/10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47EFEB-54C2-0443-84FE-B5A772B27A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A63F0D1-509F-874C-8BF7-1332682B45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F429F3-0681-C442-86DD-2B9D51AF7A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55923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0C66EF-3978-4145-8E32-211D7F1856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87A1AA3-ABF7-2441-AA82-A8A4FE83DF8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322BCC-0DE0-9343-AB24-D399408734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79C092-4A4A-EA4A-975E-A9AB075828AA}" type="datetimeFigureOut">
              <a:rPr lang="en-US" smtClean="0"/>
              <a:t>3/10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0657B3D-D254-E945-9EA9-A4FDEB76B6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95E34B2-D6DE-2641-BF59-3330B088C9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F429F3-0681-C442-86DD-2B9D51AF7A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77065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8818BF6-6899-DC49-80A3-F0B9BD846E0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AF05E4D-258A-EE4D-877F-4DC0ADD543C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0F7B44A-026B-BC49-BE43-006AF4D8A8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79C092-4A4A-EA4A-975E-A9AB075828AA}" type="datetimeFigureOut">
              <a:rPr lang="en-US" smtClean="0"/>
              <a:t>3/10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419CFD9-8F3C-CD42-B5AF-B0649065D4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BA2B394-6399-E444-818D-C9357684AE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F429F3-0681-C442-86DD-2B9D51AF7A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32483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B46D64-39B0-F44A-A795-E58D7A5BD4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66B918E-A368-6C4A-8CA8-C0BF588A57F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3175FA2-6E6E-B344-961E-767C844E38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79C092-4A4A-EA4A-975E-A9AB075828AA}" type="datetimeFigureOut">
              <a:rPr lang="en-US" smtClean="0"/>
              <a:t>3/10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4CE7EE3-8435-944F-B7C0-372C823C5B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0B13CCD-DA97-9041-A63C-603FF6D822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F429F3-0681-C442-86DD-2B9D51AF7A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3433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4C7032-5168-6045-9EF6-5A4976B2D7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D8ACA56-5FCE-6747-979D-7DC01E44051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1D5EE32-508D-2A42-80DD-A10214B974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79C092-4A4A-EA4A-975E-A9AB075828AA}" type="datetimeFigureOut">
              <a:rPr lang="en-US" smtClean="0"/>
              <a:t>3/10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8C00587-854A-8B48-9A0B-475D9CC31B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9D48478-76B8-BA4F-B0B7-BAD68F48DB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F429F3-0681-C442-86DD-2B9D51AF7A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19963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AB2A4F-4351-3941-A111-51903BDBB5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C8C90C5-E3BC-8E46-948E-C31FB071A42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84650EB-A0F0-9B4E-BC25-B1575E018F4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07BC2EC-55AD-F84B-948A-0C38B01205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79C092-4A4A-EA4A-975E-A9AB075828AA}" type="datetimeFigureOut">
              <a:rPr lang="en-US" smtClean="0"/>
              <a:t>3/10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12BF256-9BBA-FE40-B8D1-07964FD2E8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45F3963-DB2E-6E41-80D3-439199944C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F429F3-0681-C442-86DD-2B9D51AF7A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99994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AEF587-2F37-A446-90D1-E9A356F6AB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44DCE19-620C-E14E-81AC-6D6D4816770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5207B7B-DEDB-E04A-BAFB-B345546A6C2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2563878-7F12-9F4A-B0EB-4C621F6553B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FCBB35C-A0FE-0145-807C-01F93C5CBA6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531A6D7-8385-ED46-A9D9-8B1F13921A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79C092-4A4A-EA4A-975E-A9AB075828AA}" type="datetimeFigureOut">
              <a:rPr lang="en-US" smtClean="0"/>
              <a:t>3/10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77EDF53-9E85-9B40-BFA6-5934590AE4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58FDFFD-C946-4A47-A684-4C64E8406E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F429F3-0681-C442-86DD-2B9D51AF7A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95450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793F51-4943-C049-846C-F713C8C413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D01F0E6-D7CA-C244-91E0-4E6B6DDC5D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79C092-4A4A-EA4A-975E-A9AB075828AA}" type="datetimeFigureOut">
              <a:rPr lang="en-US" smtClean="0"/>
              <a:t>3/10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2884C85-D9A0-B546-A019-FAF981CB1C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575EB98-930F-8E49-A6C8-3A258C13D4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F429F3-0681-C442-86DD-2B9D51AF7A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36911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418D2DB-ABAE-9747-B3D0-E9306EF52F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79C092-4A4A-EA4A-975E-A9AB075828AA}" type="datetimeFigureOut">
              <a:rPr lang="en-US" smtClean="0"/>
              <a:t>3/10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D4C8D6F-4760-A545-8F8B-5519CDE920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6FF6F28-0E93-F542-AF30-7601F65BAC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F429F3-0681-C442-86DD-2B9D51AF7A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83350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693418-AA69-E143-A122-5C90754D66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511AFE9-F758-974B-AB29-6F9DE41ECF3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0743479-8891-3D47-BAAC-2494BD3144F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00DB52C-FDB4-F944-868F-FC49FAADC5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79C092-4A4A-EA4A-975E-A9AB075828AA}" type="datetimeFigureOut">
              <a:rPr lang="en-US" smtClean="0"/>
              <a:t>3/10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A838ECE-CE18-614F-8927-BB120F01A7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60723D9-4C4B-3842-9D82-32B574AEFF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F429F3-0681-C442-86DD-2B9D51AF7A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6664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346EEB-C907-5848-9806-43489D21DA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8630AF7-139D-F849-AF8B-2A4472D7CFC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600D7E4-4B55-9546-ABA9-F4EB68CB4FA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CE23E03-4FF4-8F47-91CA-07CE9B06EF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79C092-4A4A-EA4A-975E-A9AB075828AA}" type="datetimeFigureOut">
              <a:rPr lang="en-US" smtClean="0"/>
              <a:t>3/10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E664E45-B129-1843-9CC4-EB4F84DF49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C10CE79-71D0-044D-8CC6-151CBA4448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F429F3-0681-C442-86DD-2B9D51AF7A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883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D6A4F72-702C-4947-8C90-96F70A432F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DADB44E-90E2-8548-9049-45FDEF26FCC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4383B8-C8C3-5F4F-A5BE-0874DC14A1A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79C092-4A4A-EA4A-975E-A9AB075828AA}" type="datetimeFigureOut">
              <a:rPr lang="en-US" smtClean="0"/>
              <a:t>3/10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29CEA8C-5ED5-5041-B2D9-6841D08D798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F7F6B03-7986-304A-96DB-7D924F6B050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F429F3-0681-C442-86DD-2B9D51AF7A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47859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73D0FF-18E4-C84A-B8E0-1E3BFE78CD88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>
            <a:normAutofit fontScale="90000"/>
          </a:bodyPr>
          <a:lstStyle/>
          <a:p>
            <a:r>
              <a:rPr lang="en-US" dirty="0">
                <a:latin typeface="Calibri" panose="020F0502020204030204" pitchFamily="34" charset="0"/>
                <a:cs typeface="Calibri" panose="020F0502020204030204" pitchFamily="34" charset="0"/>
              </a:rPr>
              <a:t>Mixed-effects logistic regression model outputs with North America, U.S. as referenc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1246EF0-9E84-AF46-97AA-5D424CBAAA93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070107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screenshot of a document&#10;&#10;Description automatically generated">
            <a:extLst>
              <a:ext uri="{FF2B5EF4-FFF2-40B4-BE49-F238E27FC236}">
                <a16:creationId xmlns:a16="http://schemas.microsoft.com/office/drawing/2014/main" id="{72F728CE-AB57-3D4E-B507-F0A21F1C5AC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05779" y="0"/>
            <a:ext cx="5580442" cy="68580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684F86A7-F983-684C-8F53-F7F739DF4116}"/>
              </a:ext>
            </a:extLst>
          </p:cNvPr>
          <p:cNvSpPr txBox="1"/>
          <p:nvPr/>
        </p:nvSpPr>
        <p:spPr>
          <a:xfrm>
            <a:off x="8886221" y="0"/>
            <a:ext cx="336181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pecialist Journal ((</a:t>
            </a:r>
            <a:r>
              <a:rPr lang="en-US" i="1" dirty="0"/>
              <a:t>Antiquity</a:t>
            </a:r>
            <a:r>
              <a:rPr lang="en-US" dirty="0"/>
              <a:t> only)</a:t>
            </a:r>
          </a:p>
          <a:p>
            <a:r>
              <a:rPr lang="en-US" dirty="0"/>
              <a:t>Country (USA reference)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1C50E8B7-24CF-4047-8B0C-06AB34111199}"/>
              </a:ext>
            </a:extLst>
          </p:cNvPr>
          <p:cNvSpPr/>
          <p:nvPr/>
        </p:nvSpPr>
        <p:spPr>
          <a:xfrm>
            <a:off x="3663560" y="6498486"/>
            <a:ext cx="573027" cy="109517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199932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screenshot of a computer&#10;&#10;Description automatically generated">
            <a:extLst>
              <a:ext uri="{FF2B5EF4-FFF2-40B4-BE49-F238E27FC236}">
                <a16:creationId xmlns:a16="http://schemas.microsoft.com/office/drawing/2014/main" id="{3D1B1DD5-2632-F649-8B8F-83BAEE1ABE8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70476" y="0"/>
            <a:ext cx="9251048" cy="6858000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ECE3464D-2493-5849-81DA-0F818EA76E98}"/>
              </a:ext>
            </a:extLst>
          </p:cNvPr>
          <p:cNvSpPr/>
          <p:nvPr/>
        </p:nvSpPr>
        <p:spPr>
          <a:xfrm>
            <a:off x="5843588" y="2489729"/>
            <a:ext cx="605969" cy="182034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4E112A13-BF77-D946-98AB-38191908CC3B}"/>
              </a:ext>
            </a:extLst>
          </p:cNvPr>
          <p:cNvSpPr/>
          <p:nvPr/>
        </p:nvSpPr>
        <p:spPr>
          <a:xfrm>
            <a:off x="5843587" y="2899304"/>
            <a:ext cx="605969" cy="182034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CD22B2FD-7D4C-0B43-99A2-4135C8CF3577}"/>
              </a:ext>
            </a:extLst>
          </p:cNvPr>
          <p:cNvSpPr/>
          <p:nvPr/>
        </p:nvSpPr>
        <p:spPr>
          <a:xfrm>
            <a:off x="1285103" y="3177330"/>
            <a:ext cx="5164453" cy="443199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3465E283-3D74-0D48-AC2A-94468F9834F6}"/>
              </a:ext>
            </a:extLst>
          </p:cNvPr>
          <p:cNvSpPr/>
          <p:nvPr/>
        </p:nvSpPr>
        <p:spPr>
          <a:xfrm>
            <a:off x="5924469" y="5484632"/>
            <a:ext cx="525087" cy="172870"/>
          </a:xfrm>
          <a:prstGeom prst="rect">
            <a:avLst/>
          </a:prstGeom>
          <a:solidFill>
            <a:schemeClr val="accent1">
              <a:lumMod val="75000"/>
              <a:alpha val="2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0B815D0C-2B7F-E747-B411-05A1B4D607A7}"/>
              </a:ext>
            </a:extLst>
          </p:cNvPr>
          <p:cNvSpPr/>
          <p:nvPr/>
        </p:nvSpPr>
        <p:spPr>
          <a:xfrm>
            <a:off x="5924469" y="5807772"/>
            <a:ext cx="525087" cy="172870"/>
          </a:xfrm>
          <a:prstGeom prst="rect">
            <a:avLst/>
          </a:prstGeom>
          <a:solidFill>
            <a:schemeClr val="accent1">
              <a:lumMod val="75000"/>
              <a:alpha val="2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F0D441D5-52F7-E241-9B39-4CF3C9944C61}"/>
              </a:ext>
            </a:extLst>
          </p:cNvPr>
          <p:cNvSpPr/>
          <p:nvPr/>
        </p:nvSpPr>
        <p:spPr>
          <a:xfrm>
            <a:off x="5843586" y="6237287"/>
            <a:ext cx="605969" cy="182034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F8477B9-2009-004C-A8E4-E8F9883EF6FF}"/>
              </a:ext>
            </a:extLst>
          </p:cNvPr>
          <p:cNvSpPr txBox="1"/>
          <p:nvPr/>
        </p:nvSpPr>
        <p:spPr>
          <a:xfrm>
            <a:off x="8514583" y="0"/>
            <a:ext cx="367741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ll Journals</a:t>
            </a:r>
          </a:p>
          <a:p>
            <a:r>
              <a:rPr lang="en-US" dirty="0"/>
              <a:t>Continent (North America Reference)</a:t>
            </a:r>
          </a:p>
        </p:txBody>
      </p:sp>
    </p:spTree>
    <p:extLst>
      <p:ext uri="{BB962C8B-B14F-4D97-AF65-F5344CB8AC3E}">
        <p14:creationId xmlns:p14="http://schemas.microsoft.com/office/powerpoint/2010/main" val="291976998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screenshot of a document&#10;&#10;Description automatically generated">
            <a:extLst>
              <a:ext uri="{FF2B5EF4-FFF2-40B4-BE49-F238E27FC236}">
                <a16:creationId xmlns:a16="http://schemas.microsoft.com/office/drawing/2014/main" id="{6C49A2B9-6F7A-824C-8863-6562C0D4EBE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24591" y="0"/>
            <a:ext cx="8342817" cy="6858000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5007E07B-B55C-124A-A3DF-C32E7675C853}"/>
              </a:ext>
            </a:extLst>
          </p:cNvPr>
          <p:cNvSpPr/>
          <p:nvPr/>
        </p:nvSpPr>
        <p:spPr>
          <a:xfrm>
            <a:off x="5793014" y="2207325"/>
            <a:ext cx="605969" cy="182034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C107CFC3-8024-A546-A10E-55DE5F43FB65}"/>
              </a:ext>
            </a:extLst>
          </p:cNvPr>
          <p:cNvSpPr/>
          <p:nvPr/>
        </p:nvSpPr>
        <p:spPr>
          <a:xfrm>
            <a:off x="5793014" y="2594504"/>
            <a:ext cx="605969" cy="182034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BC78583D-93C3-604A-988E-9936635A6AB0}"/>
              </a:ext>
            </a:extLst>
          </p:cNvPr>
          <p:cNvSpPr/>
          <p:nvPr/>
        </p:nvSpPr>
        <p:spPr>
          <a:xfrm>
            <a:off x="1924592" y="2890666"/>
            <a:ext cx="4460218" cy="346804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275EEEB9-5B82-564A-8DE0-4A21396603C0}"/>
              </a:ext>
            </a:extLst>
          </p:cNvPr>
          <p:cNvSpPr/>
          <p:nvPr/>
        </p:nvSpPr>
        <p:spPr>
          <a:xfrm>
            <a:off x="5471411" y="4726252"/>
            <a:ext cx="922124" cy="93086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E4B4090B-EFBC-6848-B142-78948AB69795}"/>
              </a:ext>
            </a:extLst>
          </p:cNvPr>
          <p:cNvSpPr/>
          <p:nvPr/>
        </p:nvSpPr>
        <p:spPr>
          <a:xfrm>
            <a:off x="5793014" y="6261577"/>
            <a:ext cx="591796" cy="146718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9CC0D19-A015-1145-8FCF-411ED326EA7F}"/>
              </a:ext>
            </a:extLst>
          </p:cNvPr>
          <p:cNvSpPr txBox="1"/>
          <p:nvPr/>
        </p:nvSpPr>
        <p:spPr>
          <a:xfrm>
            <a:off x="8192700" y="0"/>
            <a:ext cx="399930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ll Journals</a:t>
            </a:r>
          </a:p>
          <a:p>
            <a:r>
              <a:rPr lang="en-US" dirty="0"/>
              <a:t>Subcontinent (North America Reference)</a:t>
            </a:r>
          </a:p>
        </p:txBody>
      </p:sp>
    </p:spTree>
    <p:extLst>
      <p:ext uri="{BB962C8B-B14F-4D97-AF65-F5344CB8AC3E}">
        <p14:creationId xmlns:p14="http://schemas.microsoft.com/office/powerpoint/2010/main" val="143611682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screenshot of a document&#10;&#10;Description automatically generated">
            <a:extLst>
              <a:ext uri="{FF2B5EF4-FFF2-40B4-BE49-F238E27FC236}">
                <a16:creationId xmlns:a16="http://schemas.microsoft.com/office/drawing/2014/main" id="{26E7CD92-E9FE-C644-89B6-E7226AF73A3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10969" y="0"/>
            <a:ext cx="7770061" cy="6858000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E7E01493-A7E9-2C4D-87D7-297FB5395F4C}"/>
              </a:ext>
            </a:extLst>
          </p:cNvPr>
          <p:cNvSpPr/>
          <p:nvPr/>
        </p:nvSpPr>
        <p:spPr>
          <a:xfrm>
            <a:off x="5890845" y="2088559"/>
            <a:ext cx="573027" cy="109517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1AFA6C3E-582B-0A43-B81C-6229AF40AA05}"/>
              </a:ext>
            </a:extLst>
          </p:cNvPr>
          <p:cNvSpPr/>
          <p:nvPr/>
        </p:nvSpPr>
        <p:spPr>
          <a:xfrm>
            <a:off x="5890845" y="2469559"/>
            <a:ext cx="573027" cy="109517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1E477F10-E19A-C242-BB6A-0BD03D5C5C82}"/>
              </a:ext>
            </a:extLst>
          </p:cNvPr>
          <p:cNvSpPr/>
          <p:nvPr/>
        </p:nvSpPr>
        <p:spPr>
          <a:xfrm>
            <a:off x="2210969" y="2723458"/>
            <a:ext cx="4252904" cy="327473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E07BA670-D694-4345-8FCA-9AF5F95FA68D}"/>
              </a:ext>
            </a:extLst>
          </p:cNvPr>
          <p:cNvSpPr/>
          <p:nvPr/>
        </p:nvSpPr>
        <p:spPr>
          <a:xfrm>
            <a:off x="5890845" y="6508159"/>
            <a:ext cx="573027" cy="109517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92025A3-F1E3-2B45-88D5-E8613D671777}"/>
              </a:ext>
            </a:extLst>
          </p:cNvPr>
          <p:cNvSpPr txBox="1"/>
          <p:nvPr/>
        </p:nvSpPr>
        <p:spPr>
          <a:xfrm>
            <a:off x="9728312" y="0"/>
            <a:ext cx="246368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ll Journals</a:t>
            </a:r>
          </a:p>
          <a:p>
            <a:r>
              <a:rPr lang="en-US" dirty="0"/>
              <a:t>Country (USA reference)</a:t>
            </a:r>
          </a:p>
        </p:txBody>
      </p:sp>
    </p:spTree>
    <p:extLst>
      <p:ext uri="{BB962C8B-B14F-4D97-AF65-F5344CB8AC3E}">
        <p14:creationId xmlns:p14="http://schemas.microsoft.com/office/powerpoint/2010/main" val="182079756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screenshot of a computer&#10;&#10;Description automatically generated">
            <a:extLst>
              <a:ext uri="{FF2B5EF4-FFF2-40B4-BE49-F238E27FC236}">
                <a16:creationId xmlns:a16="http://schemas.microsoft.com/office/drawing/2014/main" id="{0753A152-22F0-A646-AE0C-A52F74C9CDD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26139" y="0"/>
            <a:ext cx="9539722" cy="68580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0083BF78-3B60-9D4B-BAF7-2D98F068A397}"/>
              </a:ext>
            </a:extLst>
          </p:cNvPr>
          <p:cNvSpPr txBox="1"/>
          <p:nvPr/>
        </p:nvSpPr>
        <p:spPr>
          <a:xfrm>
            <a:off x="8514583" y="0"/>
            <a:ext cx="367741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eneral Science Journals</a:t>
            </a:r>
          </a:p>
          <a:p>
            <a:r>
              <a:rPr lang="en-US" dirty="0"/>
              <a:t>Continent (North America Reference)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5D9CF65E-7602-E44C-B82A-05D72BD08DBE}"/>
              </a:ext>
            </a:extLst>
          </p:cNvPr>
          <p:cNvSpPr/>
          <p:nvPr/>
        </p:nvSpPr>
        <p:spPr>
          <a:xfrm>
            <a:off x="5809486" y="2558459"/>
            <a:ext cx="573027" cy="109517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076A66D6-B536-C441-B4DB-83692C59D3EC}"/>
              </a:ext>
            </a:extLst>
          </p:cNvPr>
          <p:cNvSpPr/>
          <p:nvPr/>
        </p:nvSpPr>
        <p:spPr>
          <a:xfrm>
            <a:off x="5809486" y="6266859"/>
            <a:ext cx="573027" cy="109517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117B08D2-1366-8F4A-A42E-7B05575FB5AA}"/>
              </a:ext>
            </a:extLst>
          </p:cNvPr>
          <p:cNvSpPr/>
          <p:nvPr/>
        </p:nvSpPr>
        <p:spPr>
          <a:xfrm>
            <a:off x="1369966" y="3002419"/>
            <a:ext cx="5125101" cy="291623"/>
          </a:xfrm>
          <a:prstGeom prst="rect">
            <a:avLst/>
          </a:prstGeom>
          <a:solidFill>
            <a:schemeClr val="accent1">
              <a:lumMod val="75000"/>
              <a:alpha val="2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DD34916E-59CF-B844-9DAD-46B78147EE78}"/>
              </a:ext>
            </a:extLst>
          </p:cNvPr>
          <p:cNvSpPr/>
          <p:nvPr/>
        </p:nvSpPr>
        <p:spPr>
          <a:xfrm>
            <a:off x="1369966" y="3429000"/>
            <a:ext cx="5125101" cy="291623"/>
          </a:xfrm>
          <a:prstGeom prst="rect">
            <a:avLst/>
          </a:prstGeom>
          <a:solidFill>
            <a:schemeClr val="accent1">
              <a:lumMod val="75000"/>
              <a:alpha val="2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5E41766F-662E-EB4D-BBF3-D8E3FD22D1DC}"/>
              </a:ext>
            </a:extLst>
          </p:cNvPr>
          <p:cNvSpPr/>
          <p:nvPr/>
        </p:nvSpPr>
        <p:spPr>
          <a:xfrm>
            <a:off x="5922040" y="5345035"/>
            <a:ext cx="573027" cy="291623"/>
          </a:xfrm>
          <a:prstGeom prst="rect">
            <a:avLst/>
          </a:prstGeom>
          <a:solidFill>
            <a:schemeClr val="accent1">
              <a:lumMod val="75000"/>
              <a:alpha val="2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1381ECB0-AE6B-A94C-A619-4EBEC5C52FD7}"/>
              </a:ext>
            </a:extLst>
          </p:cNvPr>
          <p:cNvSpPr/>
          <p:nvPr/>
        </p:nvSpPr>
        <p:spPr>
          <a:xfrm>
            <a:off x="5922039" y="5792990"/>
            <a:ext cx="573027" cy="109518"/>
          </a:xfrm>
          <a:prstGeom prst="rect">
            <a:avLst/>
          </a:prstGeom>
          <a:solidFill>
            <a:schemeClr val="accent1">
              <a:lumMod val="75000"/>
              <a:alpha val="2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3167065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screenshot of a computer&#10;&#10;Description automatically generated">
            <a:extLst>
              <a:ext uri="{FF2B5EF4-FFF2-40B4-BE49-F238E27FC236}">
                <a16:creationId xmlns:a16="http://schemas.microsoft.com/office/drawing/2014/main" id="{C6D85701-7DE7-CF4F-BEC2-D6080D7BB26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01" r="-1"/>
          <a:stretch/>
        </p:blipFill>
        <p:spPr>
          <a:xfrm>
            <a:off x="1793174" y="0"/>
            <a:ext cx="8631634" cy="68580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7F04F45C-BA0C-3E4A-A555-5F95A4F00B6E}"/>
              </a:ext>
            </a:extLst>
          </p:cNvPr>
          <p:cNvSpPr txBox="1"/>
          <p:nvPr/>
        </p:nvSpPr>
        <p:spPr>
          <a:xfrm>
            <a:off x="8192700" y="0"/>
            <a:ext cx="399930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eneral Science Journals</a:t>
            </a:r>
          </a:p>
          <a:p>
            <a:r>
              <a:rPr lang="en-US" dirty="0"/>
              <a:t>Subcontinent (North America Reference)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5B8A803C-1D0B-024F-8F70-B5A0BF878330}"/>
              </a:ext>
            </a:extLst>
          </p:cNvPr>
          <p:cNvSpPr/>
          <p:nvPr/>
        </p:nvSpPr>
        <p:spPr>
          <a:xfrm>
            <a:off x="5940115" y="2368454"/>
            <a:ext cx="573027" cy="109517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EA315873-D1D6-374F-91DF-6B39E4DE174B}"/>
              </a:ext>
            </a:extLst>
          </p:cNvPr>
          <p:cNvSpPr/>
          <p:nvPr/>
        </p:nvSpPr>
        <p:spPr>
          <a:xfrm>
            <a:off x="5498276" y="4791666"/>
            <a:ext cx="1014866" cy="109517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C32095B9-79C5-2543-82E0-59A4961B9DEC}"/>
              </a:ext>
            </a:extLst>
          </p:cNvPr>
          <p:cNvSpPr/>
          <p:nvPr/>
        </p:nvSpPr>
        <p:spPr>
          <a:xfrm>
            <a:off x="5854534" y="6440357"/>
            <a:ext cx="658607" cy="109517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ED888B78-3352-3746-A8C5-824EE28C9C39}"/>
              </a:ext>
            </a:extLst>
          </p:cNvPr>
          <p:cNvSpPr/>
          <p:nvPr/>
        </p:nvSpPr>
        <p:spPr>
          <a:xfrm>
            <a:off x="1388040" y="2724662"/>
            <a:ext cx="5125101" cy="291623"/>
          </a:xfrm>
          <a:prstGeom prst="rect">
            <a:avLst/>
          </a:prstGeom>
          <a:solidFill>
            <a:schemeClr val="accent1">
              <a:lumMod val="75000"/>
              <a:alpha val="2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D514A32B-0F43-C94F-B25C-31FCED6AEF54}"/>
              </a:ext>
            </a:extLst>
          </p:cNvPr>
          <p:cNvSpPr/>
          <p:nvPr/>
        </p:nvSpPr>
        <p:spPr>
          <a:xfrm>
            <a:off x="1388040" y="3137377"/>
            <a:ext cx="5125101" cy="291623"/>
          </a:xfrm>
          <a:prstGeom prst="rect">
            <a:avLst/>
          </a:prstGeom>
          <a:solidFill>
            <a:schemeClr val="accent1">
              <a:lumMod val="75000"/>
              <a:alpha val="2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0964F281-ECE5-5345-9B8A-5DC1EB247551}"/>
              </a:ext>
            </a:extLst>
          </p:cNvPr>
          <p:cNvSpPr/>
          <p:nvPr/>
        </p:nvSpPr>
        <p:spPr>
          <a:xfrm>
            <a:off x="5940115" y="5470737"/>
            <a:ext cx="573027" cy="109517"/>
          </a:xfrm>
          <a:prstGeom prst="rect">
            <a:avLst/>
          </a:prstGeom>
          <a:solidFill>
            <a:schemeClr val="accent1">
              <a:lumMod val="75000"/>
              <a:alpha val="2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0208749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screenshot of a document&#10;&#10;Description automatically generated">
            <a:extLst>
              <a:ext uri="{FF2B5EF4-FFF2-40B4-BE49-F238E27FC236}">
                <a16:creationId xmlns:a16="http://schemas.microsoft.com/office/drawing/2014/main" id="{92E585F8-7125-9E4D-8D10-23ACD7DDA8B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70814" y="0"/>
            <a:ext cx="7850372" cy="68580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A781704D-960B-1442-AD7C-FFC1B81E7E2E}"/>
              </a:ext>
            </a:extLst>
          </p:cNvPr>
          <p:cNvSpPr txBox="1"/>
          <p:nvPr/>
        </p:nvSpPr>
        <p:spPr>
          <a:xfrm>
            <a:off x="9728312" y="0"/>
            <a:ext cx="250748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eneral Science Journals</a:t>
            </a:r>
          </a:p>
          <a:p>
            <a:r>
              <a:rPr lang="en-US" dirty="0"/>
              <a:t>Country (USA reference)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48974502-CDE3-6A4C-A7DE-FC9C708D42F9}"/>
              </a:ext>
            </a:extLst>
          </p:cNvPr>
          <p:cNvSpPr/>
          <p:nvPr/>
        </p:nvSpPr>
        <p:spPr>
          <a:xfrm>
            <a:off x="5833236" y="2130948"/>
            <a:ext cx="573027" cy="109517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4BB886CA-C4BE-5041-9C26-30C41E2A35BE}"/>
              </a:ext>
            </a:extLst>
          </p:cNvPr>
          <p:cNvSpPr/>
          <p:nvPr/>
        </p:nvSpPr>
        <p:spPr>
          <a:xfrm>
            <a:off x="5874325" y="6475337"/>
            <a:ext cx="573027" cy="109517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7A401F90-6E1B-3442-93F2-A5E1477D8DEB}"/>
              </a:ext>
            </a:extLst>
          </p:cNvPr>
          <p:cNvSpPr/>
          <p:nvPr/>
        </p:nvSpPr>
        <p:spPr>
          <a:xfrm>
            <a:off x="1322251" y="2475280"/>
            <a:ext cx="5125101" cy="291623"/>
          </a:xfrm>
          <a:prstGeom prst="rect">
            <a:avLst/>
          </a:prstGeom>
          <a:solidFill>
            <a:schemeClr val="accent1">
              <a:lumMod val="75000"/>
              <a:alpha val="2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5F19B7DA-5038-644B-BB60-FDFB23D13066}"/>
              </a:ext>
            </a:extLst>
          </p:cNvPr>
          <p:cNvSpPr/>
          <p:nvPr/>
        </p:nvSpPr>
        <p:spPr>
          <a:xfrm>
            <a:off x="1322251" y="2855906"/>
            <a:ext cx="5125101" cy="291623"/>
          </a:xfrm>
          <a:prstGeom prst="rect">
            <a:avLst/>
          </a:prstGeom>
          <a:solidFill>
            <a:schemeClr val="accent1">
              <a:lumMod val="75000"/>
              <a:alpha val="2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7520529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screenshot of a computer&#10;&#10;Description automatically generated">
            <a:extLst>
              <a:ext uri="{FF2B5EF4-FFF2-40B4-BE49-F238E27FC236}">
                <a16:creationId xmlns:a16="http://schemas.microsoft.com/office/drawing/2014/main" id="{B933CB79-D7D4-0448-9259-61FA1885E5A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16213" y="0"/>
            <a:ext cx="7159573" cy="68580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5BA27D28-BB16-4C44-9CD2-90CFC35DBC86}"/>
              </a:ext>
            </a:extLst>
          </p:cNvPr>
          <p:cNvSpPr txBox="1"/>
          <p:nvPr/>
        </p:nvSpPr>
        <p:spPr>
          <a:xfrm>
            <a:off x="8514583" y="316523"/>
            <a:ext cx="367741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pecialist Journal (</a:t>
            </a:r>
            <a:r>
              <a:rPr lang="en-US" i="1" dirty="0"/>
              <a:t>Antiquity</a:t>
            </a:r>
            <a:r>
              <a:rPr lang="en-US" dirty="0"/>
              <a:t> only)</a:t>
            </a:r>
          </a:p>
          <a:p>
            <a:r>
              <a:rPr lang="en-US" dirty="0"/>
              <a:t>Continent (North America Reference)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E86EA60C-4193-904C-8472-D444AE7577B7}"/>
              </a:ext>
            </a:extLst>
          </p:cNvPr>
          <p:cNvSpPr/>
          <p:nvPr/>
        </p:nvSpPr>
        <p:spPr>
          <a:xfrm>
            <a:off x="3026953" y="6185970"/>
            <a:ext cx="746394" cy="122233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2344059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screenshot of a computer&#10;&#10;Description automatically generated">
            <a:extLst>
              <a:ext uri="{FF2B5EF4-FFF2-40B4-BE49-F238E27FC236}">
                <a16:creationId xmlns:a16="http://schemas.microsoft.com/office/drawing/2014/main" id="{C97A81AF-4EB3-094B-8C46-C845A4EB356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26480" y="0"/>
            <a:ext cx="6939040" cy="68580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210C6333-5CA4-2042-A1C4-13C630CE0990}"/>
              </a:ext>
            </a:extLst>
          </p:cNvPr>
          <p:cNvSpPr txBox="1"/>
          <p:nvPr/>
        </p:nvSpPr>
        <p:spPr>
          <a:xfrm>
            <a:off x="8192700" y="175846"/>
            <a:ext cx="399930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pecialist Journal ((</a:t>
            </a:r>
            <a:r>
              <a:rPr lang="en-US" i="1" dirty="0"/>
              <a:t>Antiquity</a:t>
            </a:r>
            <a:r>
              <a:rPr lang="en-US" dirty="0"/>
              <a:t> only)</a:t>
            </a:r>
          </a:p>
          <a:p>
            <a:r>
              <a:rPr lang="en-US" dirty="0"/>
              <a:t>Subcontinent (North America Reference)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4E817D7B-FB63-624F-B071-1E3F7A0AEE13}"/>
              </a:ext>
            </a:extLst>
          </p:cNvPr>
          <p:cNvSpPr/>
          <p:nvPr/>
        </p:nvSpPr>
        <p:spPr>
          <a:xfrm>
            <a:off x="3131125" y="6204031"/>
            <a:ext cx="700095" cy="196770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920800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2</TotalTime>
  <Words>99</Words>
  <Application>Microsoft Macintosh PowerPoint</Application>
  <PresentationFormat>Widescreen</PresentationFormat>
  <Paragraphs>19</Paragraphs>
  <Slides>1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4" baseType="lpstr">
      <vt:lpstr>Arial</vt:lpstr>
      <vt:lpstr>Calibri</vt:lpstr>
      <vt:lpstr>Calibri Light</vt:lpstr>
      <vt:lpstr>Office Theme</vt:lpstr>
      <vt:lpstr>Mixed-effects logistic regression model outputs with North America, U.S. as referenc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ixed-effects logistic regression model outputs with North America, U.S. as reference</dc:title>
  <dc:creator>Jenny Ji</dc:creator>
  <cp:lastModifiedBy>Alex, Bridget A.</cp:lastModifiedBy>
  <cp:revision>10</cp:revision>
  <dcterms:created xsi:type="dcterms:W3CDTF">2025-03-09T20:22:58Z</dcterms:created>
  <dcterms:modified xsi:type="dcterms:W3CDTF">2025-03-10T14:58:02Z</dcterms:modified>
</cp:coreProperties>
</file>